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3" r:id="rId2"/>
  </p:sldIdLst>
  <p:sldSz cx="6492875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0042" autoAdjust="0"/>
    <p:restoredTop sz="94660"/>
  </p:normalViewPr>
  <p:slideViewPr>
    <p:cSldViewPr snapToGrid="0">
      <p:cViewPr varScale="1">
        <p:scale>
          <a:sx n="89" d="100"/>
          <a:sy n="89" d="100"/>
        </p:scale>
        <p:origin x="294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02EFE9-E17E-48A4-BD8A-CA79ACF7271C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43000"/>
            <a:ext cx="219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0229D6-103D-4C95-91C8-A567FA2A8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0895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1496484"/>
            <a:ext cx="5518944" cy="3183467"/>
          </a:xfrm>
        </p:spPr>
        <p:txBody>
          <a:bodyPr anchor="b"/>
          <a:lstStyle>
            <a:lvl1pPr algn="ctr"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610" y="4802717"/>
            <a:ext cx="4869656" cy="2207683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658" indent="0" algn="ctr">
              <a:buNone/>
              <a:defRPr sz="1420"/>
            </a:lvl2pPr>
            <a:lvl3pPr marL="649315" indent="0" algn="ctr">
              <a:buNone/>
              <a:defRPr sz="1278"/>
            </a:lvl3pPr>
            <a:lvl4pPr marL="973973" indent="0" algn="ctr">
              <a:buNone/>
              <a:defRPr sz="1136"/>
            </a:lvl4pPr>
            <a:lvl5pPr marL="1298631" indent="0" algn="ctr">
              <a:buNone/>
              <a:defRPr sz="1136"/>
            </a:lvl5pPr>
            <a:lvl6pPr marL="1623289" indent="0" algn="ctr">
              <a:buNone/>
              <a:defRPr sz="1136"/>
            </a:lvl6pPr>
            <a:lvl7pPr marL="1947946" indent="0" algn="ctr">
              <a:buNone/>
              <a:defRPr sz="1136"/>
            </a:lvl7pPr>
            <a:lvl8pPr marL="2272604" indent="0" algn="ctr">
              <a:buNone/>
              <a:defRPr sz="1136"/>
            </a:lvl8pPr>
            <a:lvl9pPr marL="2597262" indent="0" algn="ctr">
              <a:buNone/>
              <a:defRPr sz="11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400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847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6464" y="486834"/>
            <a:ext cx="140002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385" y="486834"/>
            <a:ext cx="4118918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155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46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04" y="2279653"/>
            <a:ext cx="5600105" cy="3803649"/>
          </a:xfrm>
        </p:spPr>
        <p:txBody>
          <a:bodyPr anchor="b"/>
          <a:lstStyle>
            <a:lvl1pPr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004" y="6119286"/>
            <a:ext cx="5600105" cy="2000249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>
                    <a:tint val="82000"/>
                  </a:schemeClr>
                </a:solidFill>
              </a:defRPr>
            </a:lvl1pPr>
            <a:lvl2pPr marL="324658" indent="0">
              <a:buNone/>
              <a:defRPr sz="1420">
                <a:solidFill>
                  <a:schemeClr val="tx1">
                    <a:tint val="82000"/>
                  </a:schemeClr>
                </a:solidFill>
              </a:defRPr>
            </a:lvl2pPr>
            <a:lvl3pPr marL="649315" indent="0">
              <a:buNone/>
              <a:defRPr sz="1278">
                <a:solidFill>
                  <a:schemeClr val="tx1">
                    <a:tint val="82000"/>
                  </a:schemeClr>
                </a:solidFill>
              </a:defRPr>
            </a:lvl3pPr>
            <a:lvl4pPr marL="973973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4pPr>
            <a:lvl5pPr marL="1298631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5pPr>
            <a:lvl6pPr marL="1623289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6pPr>
            <a:lvl7pPr marL="1947946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7pPr>
            <a:lvl8pPr marL="2272604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8pPr>
            <a:lvl9pPr marL="2597262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104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385" y="2434167"/>
            <a:ext cx="2759472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7018" y="2434167"/>
            <a:ext cx="2759472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76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86836"/>
            <a:ext cx="560010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232" y="2241551"/>
            <a:ext cx="2746790" cy="1098549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232" y="3340100"/>
            <a:ext cx="2746790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7018" y="2241551"/>
            <a:ext cx="2760318" cy="1098549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7018" y="3340100"/>
            <a:ext cx="276031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638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30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942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609600"/>
            <a:ext cx="2094121" cy="213360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0318" y="1316569"/>
            <a:ext cx="3287018" cy="6498167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2743200"/>
            <a:ext cx="2094121" cy="50821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202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609600"/>
            <a:ext cx="2094121" cy="213360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0318" y="1316569"/>
            <a:ext cx="3287018" cy="6498167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658" indent="0">
              <a:buNone/>
              <a:defRPr sz="1988"/>
            </a:lvl2pPr>
            <a:lvl3pPr marL="649315" indent="0">
              <a:buNone/>
              <a:defRPr sz="1704"/>
            </a:lvl3pPr>
            <a:lvl4pPr marL="973973" indent="0">
              <a:buNone/>
              <a:defRPr sz="1420"/>
            </a:lvl4pPr>
            <a:lvl5pPr marL="1298631" indent="0">
              <a:buNone/>
              <a:defRPr sz="1420"/>
            </a:lvl5pPr>
            <a:lvl6pPr marL="1623289" indent="0">
              <a:buNone/>
              <a:defRPr sz="1420"/>
            </a:lvl6pPr>
            <a:lvl7pPr marL="1947946" indent="0">
              <a:buNone/>
              <a:defRPr sz="1420"/>
            </a:lvl7pPr>
            <a:lvl8pPr marL="2272604" indent="0">
              <a:buNone/>
              <a:defRPr sz="1420"/>
            </a:lvl8pPr>
            <a:lvl9pPr marL="2597262" indent="0">
              <a:buNone/>
              <a:defRPr sz="14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2743200"/>
            <a:ext cx="2094121" cy="50821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533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385" y="486836"/>
            <a:ext cx="560010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85" y="2434167"/>
            <a:ext cx="560010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385" y="8475136"/>
            <a:ext cx="1460897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765" y="8475136"/>
            <a:ext cx="219134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5593" y="8475136"/>
            <a:ext cx="1460897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140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7B083E0-2D36-4B58-63A5-4B95BFD83E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9951800"/>
              </p:ext>
            </p:extLst>
          </p:nvPr>
        </p:nvGraphicFramePr>
        <p:xfrm>
          <a:off x="112508" y="365908"/>
          <a:ext cx="6273799" cy="8129552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609553">
                  <a:extLst>
                    <a:ext uri="{9D8B030D-6E8A-4147-A177-3AD203B41FA5}">
                      <a16:colId xmlns:a16="http://schemas.microsoft.com/office/drawing/2014/main" val="3354584530"/>
                    </a:ext>
                  </a:extLst>
                </a:gridCol>
                <a:gridCol w="484439">
                  <a:extLst>
                    <a:ext uri="{9D8B030D-6E8A-4147-A177-3AD203B41FA5}">
                      <a16:colId xmlns:a16="http://schemas.microsoft.com/office/drawing/2014/main" val="3375737700"/>
                    </a:ext>
                  </a:extLst>
                </a:gridCol>
                <a:gridCol w="501650">
                  <a:extLst>
                    <a:ext uri="{9D8B030D-6E8A-4147-A177-3AD203B41FA5}">
                      <a16:colId xmlns:a16="http://schemas.microsoft.com/office/drawing/2014/main" val="3316906943"/>
                    </a:ext>
                  </a:extLst>
                </a:gridCol>
                <a:gridCol w="1397000">
                  <a:extLst>
                    <a:ext uri="{9D8B030D-6E8A-4147-A177-3AD203B41FA5}">
                      <a16:colId xmlns:a16="http://schemas.microsoft.com/office/drawing/2014/main" val="3291970844"/>
                    </a:ext>
                  </a:extLst>
                </a:gridCol>
                <a:gridCol w="793750">
                  <a:extLst>
                    <a:ext uri="{9D8B030D-6E8A-4147-A177-3AD203B41FA5}">
                      <a16:colId xmlns:a16="http://schemas.microsoft.com/office/drawing/2014/main" val="1225613483"/>
                    </a:ext>
                  </a:extLst>
                </a:gridCol>
                <a:gridCol w="1092200">
                  <a:extLst>
                    <a:ext uri="{9D8B030D-6E8A-4147-A177-3AD203B41FA5}">
                      <a16:colId xmlns:a16="http://schemas.microsoft.com/office/drawing/2014/main" val="1357360315"/>
                    </a:ext>
                  </a:extLst>
                </a:gridCol>
                <a:gridCol w="925286">
                  <a:extLst>
                    <a:ext uri="{9D8B030D-6E8A-4147-A177-3AD203B41FA5}">
                      <a16:colId xmlns:a16="http://schemas.microsoft.com/office/drawing/2014/main" val="3379385751"/>
                    </a:ext>
                  </a:extLst>
                </a:gridCol>
                <a:gridCol w="469921">
                  <a:extLst>
                    <a:ext uri="{9D8B030D-6E8A-4147-A177-3AD203B41FA5}">
                      <a16:colId xmlns:a16="http://schemas.microsoft.com/office/drawing/2014/main" val="3137914185"/>
                    </a:ext>
                  </a:extLst>
                </a:gridCol>
              </a:tblGrid>
              <a:tr h="247834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tient​</a:t>
                      </a:r>
                      <a:endParaRPr lang="en-US" b="1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der​</a:t>
                      </a:r>
                      <a:endParaRPr lang="en-US" b="1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e (years)​</a:t>
                      </a:r>
                      <a:endParaRPr lang="en-US" b="1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agnosis​</a:t>
                      </a:r>
                      <a:endParaRPr lang="en-US" b="1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rgical /Date​</a:t>
                      </a:r>
                      <a:endParaRPr lang="en-US" b="1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st medical history​</a:t>
                      </a:r>
                      <a:endParaRPr lang="en-US" b="1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nset of symptoms​</a:t>
                      </a:r>
                      <a:endParaRPr lang="en-US" b="1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ures​</a:t>
                      </a:r>
                      <a:endParaRPr lang="en-US" b="1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02233078"/>
                  </a:ext>
                </a:extLst>
              </a:tr>
              <a:tr h="171587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985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, IDH-wildtype, MGMT promoter methylation present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/28/2023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flux, Hyperlipidemia, Hypertension, Gout, Kidney stones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gnitive deficits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ght arm numbness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ght sided clumsiness. 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 A,B,C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86181504"/>
                  </a:ext>
                </a:extLst>
              </a:tr>
              <a:tr h="319632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986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, IDH-wildtype, MGMT promoter methylation present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/28/2023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abetes mellitus type 2, Hypertension, Asthma, Obstructive sleep apnea, Iron deficiency anemia 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daches, word-finding difficulties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 A,C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92037143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924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, IDH-wildtype, MGMT promoter methylation present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/07/2023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abetes mellitus type 2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ronic Kidney Diseas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daches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5A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25477952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1065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, IDH-wildtype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/25/2024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fi-FI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abetes mellitus type 2.​</a:t>
                      </a:r>
                      <a:endParaRPr lang="fi-FI" b="0" i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l" rtl="0" fontAlgn="base"/>
                      <a:r>
                        <a:rPr lang="fi-FI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yperlipidemia.​</a:t>
                      </a:r>
                      <a:endParaRPr lang="fi-FI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ght eye and ear pain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5A,B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78647344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1070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, IDH-wildtype, MGMT methylation absent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/29/2024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ypothyroidism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ght bundle branch block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sual deficits right eye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5C,D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71307964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978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, IDH-wildtype, MGMT methylation absent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/13/2023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izures. Hyperlipidemia. ​</a:t>
                      </a:r>
                      <a:b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ypothyroidism. 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sual in her right peripheral field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6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40934522"/>
                  </a:ext>
                </a:extLst>
              </a:tr>
              <a:tr h="32821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879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male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, IDH-wildtype, MGMT methylation absent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/3/2023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tention Deficit Hyperactivity Disorder. Diabetes mellitus type 2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daches. Cognitive difficulties (memory deficit.)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6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4787849"/>
                  </a:ext>
                </a:extLst>
              </a:tr>
              <a:tr h="35869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995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, IDH-wildtype, MGMT methylation present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/2/2023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ypertension. Right lower extremity deep vein thrombosis. Hyperlipidemia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ralized tonic clonic seizure. 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6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15109677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557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, IDH-wildtype, MGMT methylation present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/11/2023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ypertriglyceridemia, Cataracts, Gastroesophageal Reflux disease (GERD)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sual Disturbance described as flashing lights. Confusion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49315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6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32468195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974</a:t>
                      </a:r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sv-SE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trocytoma Grade 4, IDH(R132H) mutant, MGMT methylation present​</a:t>
                      </a:r>
                      <a:endParaRPr lang="sv-SE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/12/2023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pression. Hyperlipidemia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daches, nausea, photosensitivity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6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03107184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965</a:t>
                      </a:r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sv-SE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trocytoma Grade 4, IDH(R132H) mutant, MGMT methylation present​</a:t>
                      </a:r>
                      <a:endParaRPr lang="sv-SE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/23/2023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izure disorder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gnitive difficulties (Aphasia). Facial droop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49315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6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</a:endParaRPr>
                    </a:p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29717254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927</a:t>
                      </a:r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sv-SE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trocytoma Grade 4, IDH(R132H) mutant, MGMT methylation present​</a:t>
                      </a:r>
                      <a:endParaRPr lang="sv-SE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/13/2022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ralized Anxiety Disorder. GERD. 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gnitive difficulties (dysarthria). Facial droop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6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81226275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541</a:t>
                      </a:r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 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trocytoma Grade 4, IDH(R132H) mutant, MGMT methylation absent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/19/2022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lergic rhinitis. Gout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izure disorder. Headache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6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07482602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766</a:t>
                      </a:r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trocytoma Grade 4, IDH(R132H) mutant, MGMT methylation absent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/22/2022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abetes Mellitus type 2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zziness. Headache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6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39062729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NS108</a:t>
                      </a:r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, IDH-wildtype, MGMT methylation absent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/13/2017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ronary artery disease. Hypertension. Hyperlipidemia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gressive speech difficulty.​</a:t>
                      </a:r>
                      <a:endParaRPr lang="en-US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line​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86670010"/>
                  </a:ext>
                </a:extLst>
              </a:tr>
              <a:tr h="41992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NS871</a:t>
                      </a:r>
                      <a:endParaRPr lang="en-US" sz="7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rocytoma, IDH-mutant (WHO grade 3), MGMT methylation present.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/22/202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ized Anxiety disorder. Concussion.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nic-clonic seizure.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 6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6029911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266A915-148C-E76D-23C7-56345203D328}"/>
              </a:ext>
            </a:extLst>
          </p:cNvPr>
          <p:cNvSpPr txBox="1"/>
          <p:nvPr/>
        </p:nvSpPr>
        <p:spPr>
          <a:xfrm>
            <a:off x="112508" y="165853"/>
            <a:ext cx="70788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: Patient clinical and demographic description</a:t>
            </a:r>
          </a:p>
        </p:txBody>
      </p:sp>
    </p:spTree>
    <p:extLst>
      <p:ext uri="{BB962C8B-B14F-4D97-AF65-F5344CB8AC3E}">
        <p14:creationId xmlns:p14="http://schemas.microsoft.com/office/powerpoint/2010/main" val="3576950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1</TotalTime>
  <Words>646</Words>
  <Application>Microsoft Office PowerPoint</Application>
  <PresentationFormat>Custom</PresentationFormat>
  <Paragraphs>1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Ulloa Navas, Maria J., Ph.D., M.S.</dc:creator>
  <cp:lastModifiedBy>Ulloa Navas, Maria J., Ph.D., M.S.</cp:lastModifiedBy>
  <cp:revision>60</cp:revision>
  <dcterms:created xsi:type="dcterms:W3CDTF">2024-09-02T16:12:58Z</dcterms:created>
  <dcterms:modified xsi:type="dcterms:W3CDTF">2024-11-22T20:15:23Z</dcterms:modified>
</cp:coreProperties>
</file>